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 varScale="1">
        <p:scale>
          <a:sx n="89" d="100"/>
          <a:sy n="89" d="100"/>
        </p:scale>
        <p:origin x="298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n Ishikawa" userId="671b21c72070ca9d" providerId="LiveId" clId="{6C5CDC29-FC6A-421D-B2B9-AC9C8D41089C}"/>
    <pc:docChg chg="modSld">
      <pc:chgData name="Marin Ishikawa" userId="671b21c72070ca9d" providerId="LiveId" clId="{6C5CDC29-FC6A-421D-B2B9-AC9C8D41089C}" dt="2026-06-16T04:02:26.028" v="219" actId="1036"/>
      <pc:docMkLst>
        <pc:docMk/>
      </pc:docMkLst>
      <pc:sldChg chg="addSp modSp mod">
        <pc:chgData name="Marin Ishikawa" userId="671b21c72070ca9d" providerId="LiveId" clId="{6C5CDC29-FC6A-421D-B2B9-AC9C8D41089C}" dt="2026-06-16T04:02:26.028" v="219" actId="1036"/>
        <pc:sldMkLst>
          <pc:docMk/>
          <pc:sldMk cId="1398461736" sldId="282"/>
        </pc:sldMkLst>
        <pc:spChg chg="mod">
          <ac:chgData name="Marin Ishikawa" userId="671b21c72070ca9d" providerId="LiveId" clId="{6C5CDC29-FC6A-421D-B2B9-AC9C8D41089C}" dt="2026-06-16T04:02:03.506" v="180" actId="1036"/>
          <ac:spMkLst>
            <pc:docMk/>
            <pc:sldMk cId="1398461736" sldId="282"/>
            <ac:spMk id="2" creationId="{5CB9D952-5959-1D00-150A-D78ECCD471BA}"/>
          </ac:spMkLst>
        </pc:spChg>
        <pc:spChg chg="mod">
          <ac:chgData name="Marin Ishikawa" userId="671b21c72070ca9d" providerId="LiveId" clId="{6C5CDC29-FC6A-421D-B2B9-AC9C8D41089C}" dt="2026-06-16T04:02:03.506" v="180" actId="1036"/>
          <ac:spMkLst>
            <pc:docMk/>
            <pc:sldMk cId="1398461736" sldId="282"/>
            <ac:spMk id="5" creationId="{F6ED9D9F-0B97-2771-40CD-972C7804335A}"/>
          </ac:spMkLst>
        </pc:spChg>
        <pc:spChg chg="add mod ord">
          <ac:chgData name="Marin Ishikawa" userId="671b21c72070ca9d" providerId="LiveId" clId="{6C5CDC29-FC6A-421D-B2B9-AC9C8D41089C}" dt="2026-06-16T04:02:12.857" v="181" actId="167"/>
          <ac:spMkLst>
            <pc:docMk/>
            <pc:sldMk cId="1398461736" sldId="282"/>
            <ac:spMk id="6" creationId="{5324698D-40E2-781A-5222-A00B5C51BEB2}"/>
          </ac:spMkLst>
        </pc:spChg>
        <pc:spChg chg="mod">
          <ac:chgData name="Marin Ishikawa" userId="671b21c72070ca9d" providerId="LiveId" clId="{6C5CDC29-FC6A-421D-B2B9-AC9C8D41089C}" dt="2026-06-16T04:02:26.028" v="219" actId="1036"/>
          <ac:spMkLst>
            <pc:docMk/>
            <pc:sldMk cId="1398461736" sldId="282"/>
            <ac:spMk id="12" creationId="{57F58669-7123-D6A1-38CB-C6D27A176F96}"/>
          </ac:spMkLst>
        </pc:spChg>
        <pc:spChg chg="mod">
          <ac:chgData name="Marin Ishikawa" userId="671b21c72070ca9d" providerId="LiveId" clId="{6C5CDC29-FC6A-421D-B2B9-AC9C8D41089C}" dt="2026-06-16T04:00:36.419" v="101" actId="1036"/>
          <ac:spMkLst>
            <pc:docMk/>
            <pc:sldMk cId="1398461736" sldId="282"/>
            <ac:spMk id="15" creationId="{576986B3-3D09-71D3-C10D-CA4A42D792C9}"/>
          </ac:spMkLst>
        </pc:spChg>
        <pc:spChg chg="mod">
          <ac:chgData name="Marin Ishikawa" userId="671b21c72070ca9d" providerId="LiveId" clId="{6C5CDC29-FC6A-421D-B2B9-AC9C8D41089C}" dt="2026-06-16T04:00:57.396" v="141" actId="1035"/>
          <ac:spMkLst>
            <pc:docMk/>
            <pc:sldMk cId="1398461736" sldId="282"/>
            <ac:spMk id="28" creationId="{98D12C28-1080-FCB1-F558-AB8A7EA46030}"/>
          </ac:spMkLst>
        </pc:spChg>
        <pc:spChg chg="mod">
          <ac:chgData name="Marin Ishikawa" userId="671b21c72070ca9d" providerId="LiveId" clId="{6C5CDC29-FC6A-421D-B2B9-AC9C8D41089C}" dt="2026-06-16T04:00:57.396" v="141" actId="1035"/>
          <ac:spMkLst>
            <pc:docMk/>
            <pc:sldMk cId="1398461736" sldId="282"/>
            <ac:spMk id="30" creationId="{68536ABB-BF11-E1B5-0A9D-FBD9C63E434D}"/>
          </ac:spMkLst>
        </pc:spChg>
        <pc:spChg chg="mod">
          <ac:chgData name="Marin Ishikawa" userId="671b21c72070ca9d" providerId="LiveId" clId="{6C5CDC29-FC6A-421D-B2B9-AC9C8D41089C}" dt="2026-06-16T04:00:57.396" v="141" actId="1035"/>
          <ac:spMkLst>
            <pc:docMk/>
            <pc:sldMk cId="1398461736" sldId="282"/>
            <ac:spMk id="31" creationId="{C82F0944-C95D-8518-CF83-73BED30DA7F2}"/>
          </ac:spMkLst>
        </pc:spChg>
        <pc:spChg chg="mod">
          <ac:chgData name="Marin Ishikawa" userId="671b21c72070ca9d" providerId="LiveId" clId="{6C5CDC29-FC6A-421D-B2B9-AC9C8D41089C}" dt="2026-06-16T04:00:57.396" v="141" actId="1035"/>
          <ac:spMkLst>
            <pc:docMk/>
            <pc:sldMk cId="1398461736" sldId="282"/>
            <ac:spMk id="32" creationId="{62AE7029-FE04-8C81-311A-98515C8AFAB6}"/>
          </ac:spMkLst>
        </pc:spChg>
        <pc:spChg chg="mod">
          <ac:chgData name="Marin Ishikawa" userId="671b21c72070ca9d" providerId="LiveId" clId="{6C5CDC29-FC6A-421D-B2B9-AC9C8D41089C}" dt="2026-06-16T04:00:57.396" v="141" actId="1035"/>
          <ac:spMkLst>
            <pc:docMk/>
            <pc:sldMk cId="1398461736" sldId="282"/>
            <ac:spMk id="33" creationId="{8FB1A701-8DCA-6BF9-1980-E17D5609735D}"/>
          </ac:spMkLst>
        </pc:spChg>
        <pc:spChg chg="mod">
          <ac:chgData name="Marin Ishikawa" userId="671b21c72070ca9d" providerId="LiveId" clId="{6C5CDC29-FC6A-421D-B2B9-AC9C8D41089C}" dt="2026-06-16T04:00:57.396" v="141" actId="1035"/>
          <ac:spMkLst>
            <pc:docMk/>
            <pc:sldMk cId="1398461736" sldId="282"/>
            <ac:spMk id="36" creationId="{C0E5108C-F92E-2449-B8ED-70A64C1505E5}"/>
          </ac:spMkLst>
        </pc:spChg>
        <pc:spChg chg="mod">
          <ac:chgData name="Marin Ishikawa" userId="671b21c72070ca9d" providerId="LiveId" clId="{6C5CDC29-FC6A-421D-B2B9-AC9C8D41089C}" dt="2026-06-16T04:00:57.396" v="141" actId="1035"/>
          <ac:spMkLst>
            <pc:docMk/>
            <pc:sldMk cId="1398461736" sldId="282"/>
            <ac:spMk id="39" creationId="{BCF66542-1FF0-500F-9736-63CF00D958DE}"/>
          </ac:spMkLst>
        </pc:spChg>
        <pc:spChg chg="mod">
          <ac:chgData name="Marin Ishikawa" userId="671b21c72070ca9d" providerId="LiveId" clId="{6C5CDC29-FC6A-421D-B2B9-AC9C8D41089C}" dt="2026-06-16T04:00:57.396" v="141" actId="1035"/>
          <ac:spMkLst>
            <pc:docMk/>
            <pc:sldMk cId="1398461736" sldId="282"/>
            <ac:spMk id="40" creationId="{877BA97E-A450-CD41-AF2A-2DAA6859CA4E}"/>
          </ac:spMkLst>
        </pc:spChg>
        <pc:spChg chg="mod">
          <ac:chgData name="Marin Ishikawa" userId="671b21c72070ca9d" providerId="LiveId" clId="{6C5CDC29-FC6A-421D-B2B9-AC9C8D41089C}" dt="2026-06-16T04:00:57.396" v="141" actId="1035"/>
          <ac:spMkLst>
            <pc:docMk/>
            <pc:sldMk cId="1398461736" sldId="282"/>
            <ac:spMk id="41" creationId="{71E3656E-671F-F3B7-BD35-19374B8FD4FE}"/>
          </ac:spMkLst>
        </pc:spChg>
        <pc:spChg chg="mod">
          <ac:chgData name="Marin Ishikawa" userId="671b21c72070ca9d" providerId="LiveId" clId="{6C5CDC29-FC6A-421D-B2B9-AC9C8D41089C}" dt="2026-06-16T04:00:57.396" v="141" actId="1035"/>
          <ac:spMkLst>
            <pc:docMk/>
            <pc:sldMk cId="1398461736" sldId="282"/>
            <ac:spMk id="42" creationId="{51D5EB9E-D117-B9D1-B3D3-7686729B726E}"/>
          </ac:spMkLst>
        </pc:spChg>
        <pc:graphicFrameChg chg="mod">
          <ac:chgData name="Marin Ishikawa" userId="671b21c72070ca9d" providerId="LiveId" clId="{6C5CDC29-FC6A-421D-B2B9-AC9C8D41089C}" dt="2026-06-16T04:02:03.506" v="180" actId="1036"/>
          <ac:graphicFrameMkLst>
            <pc:docMk/>
            <pc:sldMk cId="1398461736" sldId="282"/>
            <ac:graphicFrameMk id="3" creationId="{AB6DFC0E-73C8-9BC9-449A-8C009E86BD21}"/>
          </ac:graphicFrameMkLst>
        </pc:graphicFrameChg>
        <pc:graphicFrameChg chg="mod">
          <ac:chgData name="Marin Ishikawa" userId="671b21c72070ca9d" providerId="LiveId" clId="{6C5CDC29-FC6A-421D-B2B9-AC9C8D41089C}" dt="2026-06-16T04:02:03.506" v="180" actId="1036"/>
          <ac:graphicFrameMkLst>
            <pc:docMk/>
            <pc:sldMk cId="1398461736" sldId="282"/>
            <ac:graphicFrameMk id="16" creationId="{9C340042-01AD-4316-977C-26BD6168A957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D63036-4205-4E3E-81C1-B9380269CE96}" type="datetimeFigureOut">
              <a:rPr kumimoji="1" lang="ja-JP" altLang="en-US" smtClean="0"/>
              <a:t>2026/6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D8E9F7-5934-4237-AC7A-A59BCE16B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85653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ure 1.</a:t>
            </a:r>
            <a:r>
              <a:rPr kumimoji="1" lang="ja-JP" altLang="en-US" dirty="0"/>
              <a:t> </a:t>
            </a:r>
            <a:r>
              <a:rPr kumimoji="1" lang="en-US" altLang="ja-JP" dirty="0"/>
              <a:t>Score system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508510-567B-45FA-922F-940EE876601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14417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0828E0-7BAA-9F2C-3DD4-9E4077B182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C1A371A-BAF9-6514-6536-27687D8132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17BC891-D660-BE5A-EE49-7DB2F1CF1A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1E697-F7A3-4A93-8290-2CA3C9C82AF1}" type="datetimeFigureOut">
              <a:rPr kumimoji="1" lang="ja-JP" altLang="en-US" smtClean="0"/>
              <a:t>2026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04845E4-B1CA-43A2-8A59-79C884299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60A5691-6D01-CA35-5CB1-49DC19A1DD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8706D-B1BC-4EEF-841D-01025B2B3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9473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D727F9-5D97-5A99-ACA2-C512ACE0E6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C1F3220-3F64-8DB6-74AE-DFB7B0075E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F123973-32D2-CEC1-F6D7-FB4EDBB5B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1E697-F7A3-4A93-8290-2CA3C9C82AF1}" type="datetimeFigureOut">
              <a:rPr kumimoji="1" lang="ja-JP" altLang="en-US" smtClean="0"/>
              <a:t>2026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C216C64-94E9-8852-A881-3D509FC5A2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21732B-0314-0CAC-4CF9-69DAD3B5E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8706D-B1BC-4EEF-841D-01025B2B3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76709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BCAC212-60E7-BB54-26EE-96298E3E93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CA5CCFE-56F4-9F17-5ABD-2E216C401A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228C8C1-D02F-02D3-9470-B8A2BAA65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1E697-F7A3-4A93-8290-2CA3C9C82AF1}" type="datetimeFigureOut">
              <a:rPr kumimoji="1" lang="ja-JP" altLang="en-US" smtClean="0"/>
              <a:t>2026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B60A0C1-3046-89A8-8D0D-6D900A44C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E2ED33D-48AD-9C23-C884-CFAFD49B2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8706D-B1BC-4EEF-841D-01025B2B3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5867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0FF1F6-309A-C736-8970-772907BEF0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6A83891-1BCA-A6D4-715D-5C6B611BBC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68C712E-E53C-F3DF-4A4E-70092B267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1E697-F7A3-4A93-8290-2CA3C9C82AF1}" type="datetimeFigureOut">
              <a:rPr kumimoji="1" lang="ja-JP" altLang="en-US" smtClean="0"/>
              <a:t>2026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60BE17D-7360-5A4C-9082-96A68AFE94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E23748D-C3D9-0187-145D-D616B96C94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8706D-B1BC-4EEF-841D-01025B2B3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5617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42A4C3-976B-8D52-B06F-15019EBCAF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4585254-324E-0BED-210C-EBBEF97643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8840383-2427-5975-303D-8F3495757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1E697-F7A3-4A93-8290-2CA3C9C82AF1}" type="datetimeFigureOut">
              <a:rPr kumimoji="1" lang="ja-JP" altLang="en-US" smtClean="0"/>
              <a:t>2026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A11CD1D-9CF2-8382-90C6-61CAD34031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8684852-C5DE-80DC-A58E-ADC60F93A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8706D-B1BC-4EEF-841D-01025B2B3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5538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030B314-DAF9-30ED-2B11-7174B4740F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54477B6-C2A5-A383-74A1-6A0239CF1D8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69536AA-E0E7-FDEF-87F9-B4D591F605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67BE021-284C-8228-5E8E-4F26565D69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1E697-F7A3-4A93-8290-2CA3C9C82AF1}" type="datetimeFigureOut">
              <a:rPr kumimoji="1" lang="ja-JP" altLang="en-US" smtClean="0"/>
              <a:t>2026/6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E21854A-1CED-C0EB-E9C5-2B93A089B7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1FB17C5-B4E7-FCD4-ECE4-0FC4345D9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8706D-B1BC-4EEF-841D-01025B2B3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4960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5DAE64-E862-77E7-E7F9-02FE17ADF8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3D5C8A5-FA26-0FC7-0E55-150C9D3D43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076F297-464F-784A-F90F-2FEF1CBC0C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FE244B1-8C69-3027-8063-A6D0418119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A38E7DC-42F3-D5A9-338A-9124FF477C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B86FE1D-9A06-1F29-5D1A-680D3D6043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1E697-F7A3-4A93-8290-2CA3C9C82AF1}" type="datetimeFigureOut">
              <a:rPr kumimoji="1" lang="ja-JP" altLang="en-US" smtClean="0"/>
              <a:t>2026/6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5281EAE-7DCB-0952-FF9E-9A80B7F51D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9A837CC-45F0-97A6-E7BB-3FEAC0004E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8706D-B1BC-4EEF-841D-01025B2B3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1982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B5700CD-EC68-DDD8-4AE2-6A1D1073D5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5C65529-799E-F414-2E5A-8D3A79F6A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1E697-F7A3-4A93-8290-2CA3C9C82AF1}" type="datetimeFigureOut">
              <a:rPr kumimoji="1" lang="ja-JP" altLang="en-US" smtClean="0"/>
              <a:t>2026/6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CBA6306-E7B3-816B-8E5E-C9A4B678C8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7C6A8C0-D529-A4BA-42FD-636938E15F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8706D-B1BC-4EEF-841D-01025B2B3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3835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276C327-74AF-EA0D-1DB6-CF21B692DA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1E697-F7A3-4A93-8290-2CA3C9C82AF1}" type="datetimeFigureOut">
              <a:rPr kumimoji="1" lang="ja-JP" altLang="en-US" smtClean="0"/>
              <a:t>2026/6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222AC5F-D814-0FCF-16BA-92E6A9F59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4502414-03E0-D808-7475-935488DDF4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8706D-B1BC-4EEF-841D-01025B2B3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2944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73D59D-6066-D5F1-2E7D-2D536035C7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308AD29-372E-B37F-BA7D-9248B6B07A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7D68635-0A77-B224-E20C-3073815D0E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FEA83DE-C441-3119-1C9E-654671F574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1E697-F7A3-4A93-8290-2CA3C9C82AF1}" type="datetimeFigureOut">
              <a:rPr kumimoji="1" lang="ja-JP" altLang="en-US" smtClean="0"/>
              <a:t>2026/6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570C746-7A2B-5558-A0F8-E9C32D927C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CDFE736-6AC9-3D7F-C1AE-F550D51A68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8706D-B1BC-4EEF-841D-01025B2B3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5333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36E994-ED39-A980-023B-782C04FD4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D3ED14A-2A31-11C6-9D6A-3D6D3BE15F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62F2757-A7F5-ED65-937E-43EAADF036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D5E3DA2-5B29-6090-DDF5-4527B340D9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A1E697-F7A3-4A93-8290-2CA3C9C82AF1}" type="datetimeFigureOut">
              <a:rPr kumimoji="1" lang="ja-JP" altLang="en-US" smtClean="0"/>
              <a:t>2026/6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3038362-412A-33CB-9BCF-44FA267EB0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E85AFFE-D76A-350D-1044-11A89674E3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8706D-B1BC-4EEF-841D-01025B2B3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8551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5242748-5E94-A925-2B90-96F87CAEC3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F71C8B5-2E50-C6B1-FD0D-C94B5CAD02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23833B3-6057-F0B5-10B9-B41D4231B8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A1E697-F7A3-4A93-8290-2CA3C9C82AF1}" type="datetimeFigureOut">
              <a:rPr kumimoji="1" lang="ja-JP" altLang="en-US" smtClean="0"/>
              <a:t>2026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B810C9E-D637-7754-BCA5-798C64CC0F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85B91FE-5E00-0CA3-866C-D276206756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E8706D-B1BC-4EEF-841D-01025B2B3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61517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324698D-40E2-781A-5222-A00B5C51BEB2}"/>
              </a:ext>
            </a:extLst>
          </p:cNvPr>
          <p:cNvSpPr txBox="1"/>
          <p:nvPr/>
        </p:nvSpPr>
        <p:spPr>
          <a:xfrm>
            <a:off x="-34503" y="-49488"/>
            <a:ext cx="109308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: Scoring system of genomic alteratio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表 15">
            <a:extLst>
              <a:ext uri="{FF2B5EF4-FFF2-40B4-BE49-F238E27FC236}">
                <a16:creationId xmlns:a16="http://schemas.microsoft.com/office/drawing/2014/main" id="{9C340042-01AD-4316-977C-26BD6168A95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6119608"/>
              </p:ext>
            </p:extLst>
          </p:nvPr>
        </p:nvGraphicFramePr>
        <p:xfrm>
          <a:off x="927620" y="728052"/>
          <a:ext cx="7596504" cy="173465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1376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2041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12302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1891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19490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2548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289450">
                <a:tc gridSpan="2"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pulation of carcinoma clone</a:t>
                      </a:r>
                    </a:p>
                  </a:txBody>
                  <a:tcPr marL="84406" marR="84406" marT="42203" marB="42203"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nction of genomic alteration</a:t>
                      </a:r>
                    </a:p>
                  </a:txBody>
                  <a:tcPr marL="84406" marR="84406" marT="42203" marB="42203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fect of CNA</a:t>
                      </a:r>
                    </a:p>
                  </a:txBody>
                  <a:tcPr marL="84406" marR="84406" marT="42203" marB="42203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9041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in clone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in of function</a:t>
                      </a:r>
                      <a:r>
                        <a:rPr kumimoji="1" lang="ja-JP" altLang="en-US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</a:t>
                      </a:r>
                      <a:r>
                        <a:rPr kumimoji="1" lang="ja-JP" altLang="en-US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G</a:t>
                      </a:r>
                      <a:endParaRPr kumimoji="1" lang="ja-JP" altLang="en-US" sz="12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lification of OG (CN&gt;8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9041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clone</a:t>
                      </a: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kely gain of function of OG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lification of OG (CN 4-8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9041"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ss of function of TSG**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mozygous deletion of TSG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9041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US/Benign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H of TSG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9041">
                <a:tc>
                  <a:txBody>
                    <a:bodyPr/>
                    <a:lstStyle/>
                    <a:p>
                      <a:endParaRPr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endParaRPr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D of TSG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AB6DFC0E-73C8-9BC9-449A-8C009E86BD2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649967"/>
              </p:ext>
            </p:extLst>
          </p:nvPr>
        </p:nvGraphicFramePr>
        <p:xfrm>
          <a:off x="8553976" y="728052"/>
          <a:ext cx="2298964" cy="17346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785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2041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90239">
                <a:tc gridSpan="2"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</a:t>
                      </a:r>
                    </a:p>
                  </a:txBody>
                  <a:tcPr marL="84406" marR="84406" marT="42203" marB="42203"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8883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B-H (&gt;10 </a:t>
                      </a:r>
                      <a:r>
                        <a:rPr lang="en-US" altLang="ja-JP" sz="1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SNVs/</a:t>
                      </a:r>
                      <a:r>
                        <a:rPr lang="en-US" altLang="ja-JP" sz="1100" dirty="0" err="1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Mbp</a:t>
                      </a:r>
                      <a:r>
                        <a:rPr lang="en-US" altLang="ja-JP" sz="1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8883">
                <a:tc>
                  <a:txBody>
                    <a:bodyPr/>
                    <a:lstStyle/>
                    <a:p>
                      <a:r>
                        <a:rPr kumimoji="1" lang="en-US" altLang="ja-JP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I-H</a:t>
                      </a:r>
                      <a:endParaRPr kumimoji="1" lang="en-US" altLang="ja-JP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8883">
                <a:tc>
                  <a:txBody>
                    <a:bodyPr/>
                    <a:lstStyle/>
                    <a:p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8883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8883">
                <a:tc>
                  <a:txBody>
                    <a:bodyPr/>
                    <a:lstStyle/>
                    <a:p>
                      <a:endParaRPr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tc>
                  <a:txBody>
                    <a:bodyPr/>
                    <a:lstStyle/>
                    <a:p>
                      <a:endParaRPr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4406" marR="84406" marT="42203" marB="42203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7F58669-7123-D6A1-38CB-C6D27A176F96}"/>
              </a:ext>
            </a:extLst>
          </p:cNvPr>
          <p:cNvSpPr txBox="1"/>
          <p:nvPr/>
        </p:nvSpPr>
        <p:spPr>
          <a:xfrm>
            <a:off x="706412" y="396603"/>
            <a:ext cx="35145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&lt;Score of genomic alteration&gt;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CB9D952-5959-1D00-150A-D78ECCD471BA}"/>
              </a:ext>
            </a:extLst>
          </p:cNvPr>
          <p:cNvSpPr txBox="1"/>
          <p:nvPr/>
        </p:nvSpPr>
        <p:spPr>
          <a:xfrm>
            <a:off x="2659097" y="2471404"/>
            <a:ext cx="81938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90488" indent="-90488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**Stop gained or frameshift without database registration is considered a nonsense mutation and evaluated as 1 point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76986B3-3D09-71D3-C10D-CA4A42D792C9}"/>
              </a:ext>
            </a:extLst>
          </p:cNvPr>
          <p:cNvSpPr txBox="1"/>
          <p:nvPr/>
        </p:nvSpPr>
        <p:spPr>
          <a:xfrm>
            <a:off x="897796" y="4708313"/>
            <a:ext cx="10284076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e.g. 1</a:t>
            </a:r>
          </a:p>
          <a:p>
            <a:r>
              <a: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Genomic tumor content: 36%</a:t>
            </a:r>
          </a:p>
          <a:p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p.G12D (VAF: 10.2%)</a:t>
            </a:r>
          </a:p>
          <a:p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　→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ain clone (1) + Gain of function of OG (2) + No CNA (0) = 3 </a:t>
            </a:r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⇒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ctionable genomic alteration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e.g. 2</a:t>
            </a:r>
          </a:p>
          <a:p>
            <a:r>
              <a: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Genomic tumor content: 40%</a:t>
            </a:r>
          </a:p>
          <a:p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MEN1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p.G508D (VAF: 46.7%)</a:t>
            </a:r>
          </a:p>
          <a:p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　→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ain clone (1) + VUS (0) + UPD of TSG (1) = 2 with VUS </a:t>
            </a:r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⇒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Not potentially actionable genomic alteration</a:t>
            </a: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57D435CD-1FE0-3A38-7C2D-C0A9995C8F0F}"/>
              </a:ext>
            </a:extLst>
          </p:cNvPr>
          <p:cNvSpPr/>
          <p:nvPr/>
        </p:nvSpPr>
        <p:spPr>
          <a:xfrm>
            <a:off x="2643951" y="3958301"/>
            <a:ext cx="1981145" cy="475853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844083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inor</a:t>
            </a: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98D12C28-1080-FCB1-F558-AB8A7EA46030}"/>
              </a:ext>
            </a:extLst>
          </p:cNvPr>
          <p:cNvSpPr/>
          <p:nvPr/>
        </p:nvSpPr>
        <p:spPr>
          <a:xfrm>
            <a:off x="4626068" y="3958301"/>
            <a:ext cx="1981145" cy="475853"/>
          </a:xfrm>
          <a:prstGeom prst="rect">
            <a:avLst/>
          </a:prstGeom>
          <a:solidFill>
            <a:srgbClr val="FFFF00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844083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ild</a:t>
            </a:r>
            <a:endParaRPr kumimoji="1" lang="ja-JP" altLang="en-US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F1C8002F-3A3C-B11C-593E-0AE5713A3CD7}"/>
              </a:ext>
            </a:extLst>
          </p:cNvPr>
          <p:cNvSpPr/>
          <p:nvPr/>
        </p:nvSpPr>
        <p:spPr>
          <a:xfrm>
            <a:off x="6612521" y="3958301"/>
            <a:ext cx="1981145" cy="475853"/>
          </a:xfrm>
          <a:prstGeom prst="rect">
            <a:avLst/>
          </a:prstGeom>
          <a:solidFill>
            <a:srgbClr val="FF6600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844083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oderate</a:t>
            </a:r>
            <a:endParaRPr kumimoji="1" lang="ja-JP" altLang="en-US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68536ABB-BF11-E1B5-0A9D-FBD9C63E434D}"/>
              </a:ext>
            </a:extLst>
          </p:cNvPr>
          <p:cNvSpPr/>
          <p:nvPr/>
        </p:nvSpPr>
        <p:spPr>
          <a:xfrm>
            <a:off x="8594334" y="3958301"/>
            <a:ext cx="1981145" cy="475853"/>
          </a:xfrm>
          <a:prstGeom prst="rect">
            <a:avLst/>
          </a:prstGeom>
          <a:solidFill>
            <a:srgbClr val="C00000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844083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nsiderable</a:t>
            </a:r>
            <a:endParaRPr kumimoji="1" lang="ja-JP" altLang="en-US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C82F0944-C95D-8518-CF83-73BED30DA7F2}"/>
              </a:ext>
            </a:extLst>
          </p:cNvPr>
          <p:cNvSpPr txBox="1"/>
          <p:nvPr/>
        </p:nvSpPr>
        <p:spPr>
          <a:xfrm>
            <a:off x="9391390" y="442557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844083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1242677" algn="l"/>
              </a:tabLst>
              <a:defRPr/>
            </a:pPr>
            <a:r>
              <a:rPr kumimoji="1" lang="ja-JP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≧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4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charset="-128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2AE7029-FE04-8C81-311A-98515C8AFAB6}"/>
              </a:ext>
            </a:extLst>
          </p:cNvPr>
          <p:cNvSpPr txBox="1"/>
          <p:nvPr/>
        </p:nvSpPr>
        <p:spPr>
          <a:xfrm>
            <a:off x="7499345" y="442557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tabLst>
                <a:tab pos="1346200" algn="l"/>
              </a:tabLst>
            </a:lvl1pPr>
          </a:lstStyle>
          <a:p>
            <a:pPr marL="0" marR="0" lvl="0" indent="0" algn="ctr" defTabSz="844083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1242677" algn="l"/>
              </a:tabLst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3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8FB1A701-8DCA-6BF9-1980-E17D5609735D}"/>
              </a:ext>
            </a:extLst>
          </p:cNvPr>
          <p:cNvSpPr txBox="1"/>
          <p:nvPr/>
        </p:nvSpPr>
        <p:spPr>
          <a:xfrm>
            <a:off x="5512893" y="442557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tabLst>
                <a:tab pos="1346200" algn="l"/>
              </a:tabLst>
            </a:lvl1pPr>
          </a:lstStyle>
          <a:p>
            <a:pPr marL="0" marR="0" lvl="0" indent="0" algn="ctr" defTabSz="844083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1242677" algn="l"/>
              </a:tabLst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2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charset="-128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B9A1B7E-6B1F-0442-83DA-8EEF17FC0901}"/>
              </a:ext>
            </a:extLst>
          </p:cNvPr>
          <p:cNvSpPr txBox="1"/>
          <p:nvPr/>
        </p:nvSpPr>
        <p:spPr>
          <a:xfrm>
            <a:off x="3530775" y="442557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tabLst>
                <a:tab pos="1346200" algn="l"/>
              </a:tabLst>
            </a:lvl1pPr>
          </a:lstStyle>
          <a:p>
            <a:pPr marL="0" marR="0" lvl="0" indent="0" algn="ctr" defTabSz="844083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1242677" algn="l"/>
              </a:tabLst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1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charset="-128"/>
              <a:cs typeface="Arial" panose="020B0604020202020204" pitchFamily="34" charset="0"/>
            </a:endParaRPr>
          </a:p>
        </p:txBody>
      </p: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C47F71C0-054B-3BC7-4C1F-EBAAFA047047}"/>
              </a:ext>
            </a:extLst>
          </p:cNvPr>
          <p:cNvCxnSpPr/>
          <p:nvPr/>
        </p:nvCxnSpPr>
        <p:spPr>
          <a:xfrm>
            <a:off x="4625096" y="3889828"/>
            <a:ext cx="5950383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0E5108C-F92E-2449-B8ED-70A64C1505E5}"/>
              </a:ext>
            </a:extLst>
          </p:cNvPr>
          <p:cNvSpPr txBox="1"/>
          <p:nvPr/>
        </p:nvSpPr>
        <p:spPr>
          <a:xfrm>
            <a:off x="4632814" y="3530295"/>
            <a:ext cx="44019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otentially actionable genomic alteration*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9533A622-B92E-A3EB-E451-5CE5AA89EB21}"/>
              </a:ext>
            </a:extLst>
          </p:cNvPr>
          <p:cNvCxnSpPr>
            <a:cxnSpLocks/>
          </p:cNvCxnSpPr>
          <p:nvPr/>
        </p:nvCxnSpPr>
        <p:spPr>
          <a:xfrm>
            <a:off x="5681964" y="3548356"/>
            <a:ext cx="4901233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009BCA9D-5B12-A49F-D145-10FF77C5B352}"/>
              </a:ext>
            </a:extLst>
          </p:cNvPr>
          <p:cNvSpPr txBox="1"/>
          <p:nvPr/>
        </p:nvSpPr>
        <p:spPr>
          <a:xfrm>
            <a:off x="5739314" y="3184672"/>
            <a:ext cx="3715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ctionable genomic alteration*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CF66542-1FF0-500F-9736-63CF00D958DE}"/>
              </a:ext>
            </a:extLst>
          </p:cNvPr>
          <p:cNvSpPr txBox="1"/>
          <p:nvPr/>
        </p:nvSpPr>
        <p:spPr>
          <a:xfrm>
            <a:off x="1278130" y="4397553"/>
            <a:ext cx="13605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Total score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877BA97E-A450-CD41-AF2A-2DAA6859CA4E}"/>
              </a:ext>
            </a:extLst>
          </p:cNvPr>
          <p:cNvSpPr/>
          <p:nvPr/>
        </p:nvSpPr>
        <p:spPr>
          <a:xfrm>
            <a:off x="4537980" y="3213729"/>
            <a:ext cx="6134100" cy="1488287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71E3656E-671F-F3B7-BD35-19374B8FD4FE}"/>
              </a:ext>
            </a:extLst>
          </p:cNvPr>
          <p:cNvSpPr txBox="1"/>
          <p:nvPr/>
        </p:nvSpPr>
        <p:spPr>
          <a:xfrm>
            <a:off x="9494337" y="3633658"/>
            <a:ext cx="1088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*without VU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51D5EB9E-D117-B9D1-B3D3-7686729B726E}"/>
              </a:ext>
            </a:extLst>
          </p:cNvPr>
          <p:cNvSpPr txBox="1"/>
          <p:nvPr/>
        </p:nvSpPr>
        <p:spPr>
          <a:xfrm>
            <a:off x="852483" y="4043791"/>
            <a:ext cx="1991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Effect to Cancer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28A39E3-2913-ADAB-6B2A-29AA5554CD6E}"/>
              </a:ext>
            </a:extLst>
          </p:cNvPr>
          <p:cNvSpPr txBox="1"/>
          <p:nvPr/>
        </p:nvSpPr>
        <p:spPr>
          <a:xfrm>
            <a:off x="706412" y="3126051"/>
            <a:ext cx="3715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valuation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of genomic alteration&gt;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6ED9D9F-0B97-2771-40CD-972C7804335A}"/>
              </a:ext>
            </a:extLst>
          </p:cNvPr>
          <p:cNvSpPr txBox="1"/>
          <p:nvPr/>
        </p:nvSpPr>
        <p:spPr>
          <a:xfrm>
            <a:off x="3226279" y="2700395"/>
            <a:ext cx="76266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N, copy number; CAN, copy number alteration; LOH, loss of heterozygosity; MSI-H, high mi-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crosatellite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instability; OG, oncogene; 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MB-H, high tumor mutation burden; TSG, tumor suppressor gene; UPD, uniparental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disomy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; VUS, variant of uncertain significance.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39846173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8.2"/>
</p:tagLst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06</Words>
  <Application>Microsoft Office PowerPoint</Application>
  <PresentationFormat>ワイド画面</PresentationFormat>
  <Paragraphs>6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in Ishikawa</dc:creator>
  <cp:lastModifiedBy>Marin Ishikawa</cp:lastModifiedBy>
  <cp:revision>1</cp:revision>
  <dcterms:created xsi:type="dcterms:W3CDTF">2026-06-16T03:52:53Z</dcterms:created>
  <dcterms:modified xsi:type="dcterms:W3CDTF">2026-06-16T04:02:40Z</dcterms:modified>
</cp:coreProperties>
</file>